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54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0"/>
    <p:restoredTop sz="94665"/>
  </p:normalViewPr>
  <p:slideViewPr>
    <p:cSldViewPr snapToGrid="0" snapToObjects="1" showGuides="1">
      <p:cViewPr>
        <p:scale>
          <a:sx n="241" d="100"/>
          <a:sy n="241" d="100"/>
        </p:scale>
        <p:origin x="128" y="-9320"/>
      </p:cViewPr>
      <p:guideLst>
        <p:guide orient="horz" pos="2054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Cliquez et modifiez le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Cliquez pour 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B3045-1A3F-984D-9EF1-6B0C9C10AF75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B4518-D161-C04B-A05A-A116C9C38C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8490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B3045-1A3F-984D-9EF1-6B0C9C10AF75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B4518-D161-C04B-A05A-A116C9C38C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3482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B3045-1A3F-984D-9EF1-6B0C9C10AF75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B4518-D161-C04B-A05A-A116C9C38C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1631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B3045-1A3F-984D-9EF1-6B0C9C10AF75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B4518-D161-C04B-A05A-A116C9C38C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2867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B3045-1A3F-984D-9EF1-6B0C9C10AF75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B4518-D161-C04B-A05A-A116C9C38C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318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B3045-1A3F-984D-9EF1-6B0C9C10AF75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B4518-D161-C04B-A05A-A116C9C38C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283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B3045-1A3F-984D-9EF1-6B0C9C10AF75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B4518-D161-C04B-A05A-A116C9C38C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8235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B3045-1A3F-984D-9EF1-6B0C9C10AF75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B4518-D161-C04B-A05A-A116C9C38C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0498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B3045-1A3F-984D-9EF1-6B0C9C10AF75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B4518-D161-C04B-A05A-A116C9C38C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8535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B3045-1A3F-984D-9EF1-6B0C9C10AF75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B4518-D161-C04B-A05A-A116C9C38C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9494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Cliquez et modifiez le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Faire glisser l'image vers l'espace réservé ou cliquer sur l'icône pour l'ajouter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B3045-1A3F-984D-9EF1-6B0C9C10AF75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B4518-D161-C04B-A05A-A116C9C38C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1329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AB3045-1A3F-984D-9EF1-6B0C9C10AF75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B4518-D161-C04B-A05A-A116C9C38C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0416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934" y="807674"/>
            <a:ext cx="3035300" cy="295275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188271" y="642097"/>
            <a:ext cx="91082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mr-IN" sz="800">
                <a:effectLst/>
                <a:latin typeface="Calibri" charset="0"/>
              </a:rPr>
              <a:t>TUB3-At5g62700 </a:t>
            </a:r>
            <a:endParaRPr lang="mr-IN">
              <a:effectLst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1276900" y="4001359"/>
            <a:ext cx="91082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s-IS" sz="800"/>
              <a:t>TUB5-At1g20010 </a:t>
            </a:r>
            <a:endParaRPr lang="is-IS" sz="800">
              <a:effectLst/>
            </a:endParaRPr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50926" y="806792"/>
            <a:ext cx="3034553" cy="2953631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8934" y="4185437"/>
            <a:ext cx="2986760" cy="2946320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4864771" y="4025675"/>
            <a:ext cx="91082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mr-IN" sz="800" dirty="0">
                <a:effectLst/>
                <a:latin typeface="Calibri" charset="0"/>
              </a:rPr>
              <a:t>TUB6-At5g12250 </a:t>
            </a:r>
            <a:endParaRPr lang="mr-IN" dirty="0">
              <a:effectLst/>
            </a:endParaRPr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50926" y="4216803"/>
            <a:ext cx="2936759" cy="2908357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4764356" y="642097"/>
            <a:ext cx="91082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mr-IN" sz="800">
                <a:latin typeface="Calibri" charset="0"/>
              </a:rPr>
              <a:t>TUB4-At5g44340 </a:t>
            </a:r>
            <a:endParaRPr lang="mr-IN">
              <a:effectLst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219F26D9-9470-7447-918C-23B4440C94FB}"/>
              </a:ext>
            </a:extLst>
          </p:cNvPr>
          <p:cNvSpPr/>
          <p:nvPr/>
        </p:nvSpPr>
        <p:spPr>
          <a:xfrm>
            <a:off x="165180" y="7332226"/>
            <a:ext cx="6527639" cy="9678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. S4. </a:t>
            </a:r>
            <a:r>
              <a:rPr lang="en-US" sz="10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Expression of tubulin and tubulin regulators genes in mutant seeds development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Expression of TUB3, TUB4, TUB5, TUB6, TUA6, MAPD65-1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US" sz="10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AP65-2, CLASP, KTN1, MOR1 and TBG1  in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A and ABA </a:t>
            </a:r>
            <a:r>
              <a:rPr lang="en-US" sz="10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utants seeds (indicated in figures). Data obtained through the Arabidopsis </a:t>
            </a:r>
            <a:r>
              <a:rPr lang="en-US" sz="10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eFP</a:t>
            </a:r>
            <a:r>
              <a:rPr lang="en-US" sz="10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browser at </a:t>
            </a:r>
            <a:r>
              <a:rPr lang="en-US" sz="10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bar.toronto.ca</a:t>
            </a:r>
            <a:r>
              <a:rPr lang="en-US" sz="10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endParaRPr lang="fr-FR" sz="10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22070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409215" y="970308"/>
            <a:ext cx="95891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mr-IN" sz="800" dirty="0">
                <a:effectLst/>
                <a:latin typeface="Calibri" charset="0"/>
              </a:rPr>
              <a:t>TUA6 - At4g14960 </a:t>
            </a:r>
            <a:endParaRPr lang="mr-IN" dirty="0">
              <a:effectLst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0709" y="1185752"/>
            <a:ext cx="2857721" cy="2852161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4700165" y="970308"/>
            <a:ext cx="154569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mr-IN" sz="800" dirty="0"/>
              <a:t>MAP65-1-At5g55230 </a:t>
            </a:r>
            <a:endParaRPr lang="mr-IN" sz="800" dirty="0">
              <a:effectLst/>
            </a:endParaRP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19036" y="1205775"/>
            <a:ext cx="2848700" cy="2832138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351506" y="4486762"/>
            <a:ext cx="107433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mr-IN" sz="800" dirty="0">
                <a:effectLst/>
                <a:latin typeface="Calibri" charset="0"/>
              </a:rPr>
              <a:t>MAP65-2-At4g26760 </a:t>
            </a:r>
            <a:endParaRPr lang="mr-IN" dirty="0">
              <a:effectLst/>
            </a:endParaRPr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5568" y="4809927"/>
            <a:ext cx="2866208" cy="2877404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91596" y="4809927"/>
            <a:ext cx="2870146" cy="2825648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4824918" y="4486762"/>
            <a:ext cx="98937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800" dirty="0">
                <a:latin typeface="Calibri" charset="0"/>
              </a:rPr>
              <a:t>CLASP  - At2g20190</a:t>
            </a:r>
          </a:p>
        </p:txBody>
      </p:sp>
    </p:spTree>
    <p:extLst>
      <p:ext uri="{BB962C8B-B14F-4D97-AF65-F5344CB8AC3E}">
        <p14:creationId xmlns:p14="http://schemas.microsoft.com/office/powerpoint/2010/main" val="18724969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7140" y="1081260"/>
            <a:ext cx="2876691" cy="2865433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302294" y="865816"/>
            <a:ext cx="108048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800" dirty="0">
                <a:latin typeface="Calibri" charset="0"/>
              </a:rPr>
              <a:t>KTN1 - At1g80350</a:t>
            </a: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18714" y="1097769"/>
            <a:ext cx="2834732" cy="281815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4558990" y="851362"/>
            <a:ext cx="132120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800" dirty="0">
                <a:latin typeface="Calibri" charset="0"/>
              </a:rPr>
              <a:t>MOR1 - At2g35630</a:t>
            </a:r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7140" y="4901400"/>
            <a:ext cx="2926976" cy="2904286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1426008" y="4618836"/>
            <a:ext cx="115700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800" dirty="0">
                <a:latin typeface="Calibri" charset="0"/>
              </a:rPr>
              <a:t>TBG1 - At3G61650</a:t>
            </a:r>
          </a:p>
        </p:txBody>
      </p:sp>
    </p:spTree>
    <p:extLst>
      <p:ext uri="{BB962C8B-B14F-4D97-AF65-F5344CB8AC3E}">
        <p14:creationId xmlns:p14="http://schemas.microsoft.com/office/powerpoint/2010/main" val="7806442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2</TotalTime>
  <Words>84</Words>
  <Application>Microsoft Macintosh PowerPoint</Application>
  <PresentationFormat>Format A4 (210 x 297 mm)</PresentationFormat>
  <Paragraphs>12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ristophe</dc:creator>
  <cp:lastModifiedBy>christophe bailly</cp:lastModifiedBy>
  <cp:revision>10</cp:revision>
  <dcterms:created xsi:type="dcterms:W3CDTF">2020-03-04T13:32:01Z</dcterms:created>
  <dcterms:modified xsi:type="dcterms:W3CDTF">2020-03-09T14:01:21Z</dcterms:modified>
</cp:coreProperties>
</file>